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1" r:id="rId5"/>
    <p:sldId id="264" r:id="rId6"/>
    <p:sldId id="260" r:id="rId7"/>
    <p:sldId id="265" r:id="rId8"/>
    <p:sldId id="262" r:id="rId9"/>
    <p:sldId id="26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906"/>
    <p:restoredTop sz="94694"/>
  </p:normalViewPr>
  <p:slideViewPr>
    <p:cSldViewPr snapToGrid="0" snapToObjects="1">
      <p:cViewPr varScale="1">
        <p:scale>
          <a:sx n="86" d="100"/>
          <a:sy n="86" d="100"/>
        </p:scale>
        <p:origin x="240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F5D64-620F-254C-AF97-6ECCC369BB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7DD437-E84F-684B-971B-6C9CCC18AD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814FE-7F75-C943-B8A9-87E1A5E96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051594-28A8-AD44-B4F6-C8B51DDA8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E10A5C-575D-3E40-810F-C16B9F911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50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AC9B2-DC39-7D49-B56C-E8BF5CBCE6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8CE75D-369F-CA48-A6F4-C55AFAC696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A70D5-AC17-3040-B22C-3C0A99B56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1B169-8471-DE4C-AB07-4A31B923C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BE808-8390-0248-8581-47395A8C3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726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7133A2-46A2-C94A-A245-F75F250CF6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D95122-ED2A-A349-A457-DE0305C88F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15354-7A9C-7B4B-A9E5-A74E2EED9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028B4-07A2-B647-8C0F-D7C41D6F7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DD815-7A8E-7647-A95F-8851D7C4A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253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3337C-0333-2641-8003-0F125DD09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7812F1-3D83-7440-9C34-0A006046EA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0EA59F-BD27-F74B-9941-B5D06001E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B85AFF-DD31-624F-A7E1-5E5F420CA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5E858-129C-D543-A315-8C887E5CE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247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6CB35-2090-3144-9540-7225B7025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BDFE0F-2C0C-BC4E-87CE-A3D410595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167AB6-A3AF-8F40-94A5-4BE90FDC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4F0FFB-B0C3-D547-8194-D3B8C87E7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CFAF6-0433-3E41-A141-25B81C8DF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D312C-2242-6541-A10C-C84206B83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F20A69-6059-E243-BF0A-CECC3538B7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C53F07-3EF4-AF46-AFBF-9143B49272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755416-6D78-724A-A8E7-9ABE2C395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E67007-56FC-DE48-B524-63EA742D4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A1A621-8316-404A-A5B5-5BCD0654F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539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7ADB1-B129-7247-A5C8-496F1F50B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14F0FA-013D-A545-BE5A-5DEE2DE25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825754-42DE-0449-B6C4-B2383D426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84DB4F-62D4-B94C-A031-1ECEC3BAA1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0CDBB7-EF5C-6C43-840C-7DF875257F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CE1F49-89E5-8547-AE5A-61FEB649F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DD8E7A-C93A-1948-B6BB-E3976C73E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004C37-35A5-A14F-B8E2-F4E997A5F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791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32945-7310-1643-9EC7-27CDD4947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C05727-E3C0-024C-B339-72180B910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500C5A-18A0-AE43-B1C9-57B21B9C5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AEA0E5-6875-F848-82D5-8FFE7FBB5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572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765B20-11B7-514D-B4D9-B41E5CC4C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B60C86-7B64-6644-BC22-39634707A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2444C5-2249-A943-BB91-BF7B4FA79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00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96D5A-3169-1B43-8C73-E8FDD1A0C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107552-115E-DD41-A839-7715EB70F7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04DA51-33CE-3B44-A4A5-9D0D0B98B8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68CE21-2523-D943-9314-ADF53A1E9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8236D7-CAEF-224F-BE7B-B117B9920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5FF91A-ED9D-C945-8581-673842345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286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41C00-4926-2F45-8FC8-C4B1D760C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EC6B20-41C1-6B43-ADCB-0D654D7C6A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8B9D73-4110-DF4C-AB18-42128C6889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FE2A0F-5732-D245-BEA6-CCBC3A80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7EC2AD-C394-0947-9CFF-ECBD3D729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0611FA-77C2-3A43-B941-2D507B1B8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70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46F164-8DF5-8B4B-A4BB-7BFAB3D7E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0BE29C-3C2C-C744-A8E1-C3E79FA3AA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169E5-AD0A-5145-A9C8-72005F41F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693C7-B344-1641-9B2D-349DD5C2E8BD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DCED4F-C6EA-A74A-AE65-F31FA5F28A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37F05C-0C92-E941-84D1-45FE065B7F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010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D43081-A7F4-B848-8414-E2A3BFC34AE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A1AA62-F038-6747-AC10-46D211C0611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15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CFCD6-C422-194B-9DA0-52DD189EC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3A5AE-C7C6-844D-8B66-BE0BB756E2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 		9.8 x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				14.5 g/dL</a:t>
            </a:r>
          </a:p>
          <a:p>
            <a:pPr marL="0" indent="0">
              <a:buNone/>
            </a:pPr>
            <a:r>
              <a:rPr lang="en-US" dirty="0"/>
              <a:t>Hematocrit (HCT)				3.0%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				385 x1000/mm</a:t>
            </a:r>
            <a:r>
              <a:rPr lang="en-US" baseline="30000" dirty="0"/>
              <a:t>3</a:t>
            </a:r>
            <a:r>
              <a:rPr lang="en-US" dirty="0"/>
              <a:t>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525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E1012-E20F-4D44-9488-20365AD9F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0430F0-3472-9046-A136-C8F94CC2C8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Sodium 					139 mEq/L</a:t>
            </a:r>
          </a:p>
          <a:p>
            <a:pPr marL="0" indent="0">
              <a:buNone/>
            </a:pPr>
            <a:r>
              <a:rPr lang="en-US" dirty="0"/>
              <a:t>Chloride  					100 mEq/L</a:t>
            </a:r>
          </a:p>
          <a:p>
            <a:pPr marL="0" indent="0">
              <a:buNone/>
            </a:pPr>
            <a:r>
              <a:rPr lang="en-US" dirty="0"/>
              <a:t>Potassium					5.1 mEq/L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	18mEq/L </a:t>
            </a:r>
          </a:p>
          <a:p>
            <a:pPr marL="0" indent="0">
              <a:buNone/>
            </a:pPr>
            <a:r>
              <a:rPr lang="en-US" dirty="0"/>
              <a:t>Blood Urea Nitrogen (BUN)		29 mg/dL  </a:t>
            </a:r>
          </a:p>
          <a:p>
            <a:pPr marL="0" indent="0">
              <a:buNone/>
            </a:pPr>
            <a:r>
              <a:rPr lang="en-US" dirty="0"/>
              <a:t>Creatine (Cr)		 			1.9 mg/dL </a:t>
            </a:r>
          </a:p>
          <a:p>
            <a:pPr marL="0" indent="0">
              <a:buNone/>
            </a:pPr>
            <a:r>
              <a:rPr lang="en-US" dirty="0"/>
              <a:t>Glucose 					176 m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1551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16284-09AE-1448-B87B-3D97AF8AC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Brain Natriuretic Peptide (BN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CA6C6-C3DB-BF4C-AD26-2434BFB01C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595 </a:t>
            </a:r>
            <a:r>
              <a:rPr lang="en-US" dirty="0" err="1"/>
              <a:t>pg</a:t>
            </a:r>
            <a:r>
              <a:rPr lang="en-US" dirty="0"/>
              <a:t>/mL					(0 to 100 normal range)</a:t>
            </a:r>
          </a:p>
        </p:txBody>
      </p:sp>
    </p:spTree>
    <p:extLst>
      <p:ext uri="{BB962C8B-B14F-4D97-AF65-F5344CB8AC3E}">
        <p14:creationId xmlns:p14="http://schemas.microsoft.com/office/powerpoint/2010/main" val="3307936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16284-09AE-1448-B87B-3D97AF8AC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High Sensitivity Troponin-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CA6C6-C3DB-BF4C-AD26-2434BFB01C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55 ng/mL					(4 to 60 normal range)</a:t>
            </a:r>
          </a:p>
        </p:txBody>
      </p:sp>
    </p:spTree>
    <p:extLst>
      <p:ext uri="{BB962C8B-B14F-4D97-AF65-F5344CB8AC3E}">
        <p14:creationId xmlns:p14="http://schemas.microsoft.com/office/powerpoint/2010/main" val="17709749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31439-B1F2-AF47-B5A0-BDA98D44F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53243D-79CA-4541-ACA4-4432A0E974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rothrombin time (PT) 			26 seconds</a:t>
            </a:r>
          </a:p>
          <a:p>
            <a:pPr marL="0" indent="0">
              <a:buNone/>
            </a:pPr>
            <a:r>
              <a:rPr lang="en-US" dirty="0"/>
              <a:t>Partial thromboplastin time (PTT) 	33 seconds</a:t>
            </a:r>
          </a:p>
          <a:p>
            <a:pPr marL="0" indent="0">
              <a:buNone/>
            </a:pPr>
            <a:r>
              <a:rPr lang="en-US" dirty="0"/>
              <a:t>INR 						1.2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97830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31439-B1F2-AF47-B5A0-BDA98D44F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rterial blood Gas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53243D-79CA-4541-ACA4-4432A0E974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H			7.44</a:t>
            </a:r>
          </a:p>
          <a:p>
            <a:pPr marL="0" indent="0">
              <a:buNone/>
            </a:pPr>
            <a:r>
              <a:rPr lang="en-US" dirty="0"/>
              <a:t>pCO2			38</a:t>
            </a:r>
          </a:p>
          <a:p>
            <a:pPr marL="0" indent="0">
              <a:buNone/>
            </a:pPr>
            <a:r>
              <a:rPr lang="en-US" dirty="0"/>
              <a:t>pO2			60</a:t>
            </a:r>
          </a:p>
          <a:p>
            <a:pPr marL="0" indent="0">
              <a:buNone/>
            </a:pPr>
            <a:r>
              <a:rPr lang="en-US" dirty="0"/>
              <a:t>HCO3			25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38683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7EE18-B204-BA43-AAA0-D1F88C7C82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 (ECG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F974C-0147-6D49-8945-C515E53201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335912"/>
            <a:ext cx="10515600" cy="480701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Atrial fibrillation with rapid ventricular response</a:t>
            </a:r>
          </a:p>
        </p:txBody>
      </p:sp>
      <p:pic>
        <p:nvPicPr>
          <p:cNvPr id="5" name="image9.jpg" descr="Timeline&#10;&#10;Description automatically generated">
            <a:extLst>
              <a:ext uri="{FF2B5EF4-FFF2-40B4-BE49-F238E27FC236}">
                <a16:creationId xmlns:a16="http://schemas.microsoft.com/office/drawing/2014/main" id="{9C427E00-5875-FFCA-C0EE-CDBF42684C8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1935480" y="1435855"/>
            <a:ext cx="8321040" cy="4645224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205949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2160E-D65C-BD4B-9DF2-4E8AB231A1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radiograph (CXR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D0AAFD-9BB9-6144-ACFB-EA9E11E5A2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5" name="image8.png">
            <a:extLst>
              <a:ext uri="{FF2B5EF4-FFF2-40B4-BE49-F238E27FC236}">
                <a16:creationId xmlns:a16="http://schemas.microsoft.com/office/drawing/2014/main" id="{32D6112A-5C45-CEE2-570C-4056588D666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607" r="30606"/>
          <a:stretch>
            <a:fillRect/>
          </a:stretch>
        </p:blipFill>
        <p:spPr>
          <a:xfrm>
            <a:off x="3678211" y="1432556"/>
            <a:ext cx="4835577" cy="4868641"/>
          </a:xfrm>
          <a:prstGeom prst="rect">
            <a:avLst/>
          </a:prstGeom>
          <a:ln/>
        </p:spPr>
      </p:pic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CDC0F67A-D01F-C187-56DE-E86093E2B6BB}"/>
              </a:ext>
            </a:extLst>
          </p:cNvPr>
          <p:cNvSpPr txBox="1">
            <a:spLocks/>
          </p:cNvSpPr>
          <p:nvPr/>
        </p:nvSpPr>
        <p:spPr>
          <a:xfrm>
            <a:off x="838200" y="6335912"/>
            <a:ext cx="10515600" cy="480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dirty="0"/>
              <a:t>Pulmonary Edema</a:t>
            </a:r>
          </a:p>
        </p:txBody>
      </p:sp>
    </p:spTree>
    <p:extLst>
      <p:ext uri="{BB962C8B-B14F-4D97-AF65-F5344CB8AC3E}">
        <p14:creationId xmlns:p14="http://schemas.microsoft.com/office/powerpoint/2010/main" val="2483318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43</Words>
  <Application>Microsoft Macintosh PowerPoint</Application>
  <PresentationFormat>Widescreen</PresentationFormat>
  <Paragraphs>3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Stimulus Inventory</vt:lpstr>
      <vt:lpstr>Complete blood count (CBC)</vt:lpstr>
      <vt:lpstr>Basic metabolic panel</vt:lpstr>
      <vt:lpstr>Brain Natriuretic Peptide (BNP)</vt:lpstr>
      <vt:lpstr>High Sensitivity Troponin-1</vt:lpstr>
      <vt:lpstr>Coagulation panel</vt:lpstr>
      <vt:lpstr>Arterial blood Gast</vt:lpstr>
      <vt:lpstr>Electrocardiogram (ECG)</vt:lpstr>
      <vt:lpstr>Chest radiograph (CXR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Wray, Alisa</cp:lastModifiedBy>
  <cp:revision>10</cp:revision>
  <dcterms:created xsi:type="dcterms:W3CDTF">2022-01-20T09:59:44Z</dcterms:created>
  <dcterms:modified xsi:type="dcterms:W3CDTF">2023-01-17T00:34:50Z</dcterms:modified>
</cp:coreProperties>
</file>